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80" r:id="rId2"/>
    <p:sldId id="28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39104C-1B83-C244-A700-882CA44AFBD5}" v="9" dt="2024-03-17T01:20:16.641"/>
    <p1510:client id="{91F9B2B1-14D0-0D70-99A2-CA1AD7B22056}" v="12" dt="2024-03-17T01:16:19.9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2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5" Type="http://schemas.microsoft.com/office/2015/10/relationships/revisionInfo" Target="revisionInfo.xml"/><Relationship Id="rId4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zrachi, Mark" userId="b626672d-f584-4993-b46b-d169b20273b9" providerId="ADAL" clId="{5439104C-1B83-C244-A700-882CA44AFBD5}"/>
    <pc:docChg chg="modSld">
      <pc:chgData name="Mizrachi, Mark" userId="b626672d-f584-4993-b46b-d169b20273b9" providerId="ADAL" clId="{5439104C-1B83-C244-A700-882CA44AFBD5}" dt="2024-03-17T01:20:16.641" v="23" actId="20577"/>
      <pc:docMkLst>
        <pc:docMk/>
      </pc:docMkLst>
      <pc:sldChg chg="modSp mod">
        <pc:chgData name="Mizrachi, Mark" userId="b626672d-f584-4993-b46b-d169b20273b9" providerId="ADAL" clId="{5439104C-1B83-C244-A700-882CA44AFBD5}" dt="2024-03-17T01:20:16.641" v="23" actId="20577"/>
        <pc:sldMkLst>
          <pc:docMk/>
          <pc:sldMk cId="1389900947" sldId="256"/>
        </pc:sldMkLst>
        <pc:spChg chg="mod">
          <ac:chgData name="Mizrachi, Mark" userId="b626672d-f584-4993-b46b-d169b20273b9" providerId="ADAL" clId="{5439104C-1B83-C244-A700-882CA44AFBD5}" dt="2024-03-17T01:20:16.641" v="23" actId="20577"/>
          <ac:spMkLst>
            <pc:docMk/>
            <pc:sldMk cId="1389900947" sldId="256"/>
            <ac:spMk id="24" creationId="{8D3F54E8-5B41-DAB1-7F29-32025D97BB08}"/>
          </ac:spMkLst>
        </pc:spChg>
        <pc:picChg chg="mod">
          <ac:chgData name="Mizrachi, Mark" userId="b626672d-f584-4993-b46b-d169b20273b9" providerId="ADAL" clId="{5439104C-1B83-C244-A700-882CA44AFBD5}" dt="2024-03-17T01:17:30.894" v="11" actId="1076"/>
          <ac:picMkLst>
            <pc:docMk/>
            <pc:sldMk cId="1389900947" sldId="256"/>
            <ac:picMk id="2" creationId="{66855D3F-8ECD-FF46-3616-70BF576F223B}"/>
          </ac:picMkLst>
        </pc:picChg>
        <pc:picChg chg="mod">
          <ac:chgData name="Mizrachi, Mark" userId="b626672d-f584-4993-b46b-d169b20273b9" providerId="ADAL" clId="{5439104C-1B83-C244-A700-882CA44AFBD5}" dt="2024-03-17T01:17:38.211" v="12" actId="14100"/>
          <ac:picMkLst>
            <pc:docMk/>
            <pc:sldMk cId="1389900947" sldId="256"/>
            <ac:picMk id="4" creationId="{57A8FC7F-A086-120F-C5E7-23C67BCB590B}"/>
          </ac:picMkLst>
        </pc:picChg>
        <pc:picChg chg="mod">
          <ac:chgData name="Mizrachi, Mark" userId="b626672d-f584-4993-b46b-d169b20273b9" providerId="ADAL" clId="{5439104C-1B83-C244-A700-882CA44AFBD5}" dt="2024-03-17T01:17:52.728" v="14" actId="1076"/>
          <ac:picMkLst>
            <pc:docMk/>
            <pc:sldMk cId="1389900947" sldId="256"/>
            <ac:picMk id="10" creationId="{EAE85862-5706-6E2D-B709-1F6F878D2C8B}"/>
          </ac:picMkLst>
        </pc:picChg>
      </pc:sldChg>
    </pc:docChg>
  </pc:docChgLst>
  <pc:docChgLst>
    <pc:chgData name="Mizrachi, Mark" userId="S::mmizrachi@northwell.edu::b626672d-f584-4993-b46b-d169b20273b9" providerId="AD" clId="Web-{91F9B2B1-14D0-0D70-99A2-CA1AD7B22056}"/>
    <pc:docChg chg="modSld">
      <pc:chgData name="Mizrachi, Mark" userId="S::mmizrachi@northwell.edu::b626672d-f584-4993-b46b-d169b20273b9" providerId="AD" clId="Web-{91F9B2B1-14D0-0D70-99A2-CA1AD7B22056}" dt="2024-03-17T01:16:19.939" v="8" actId="1076"/>
      <pc:docMkLst>
        <pc:docMk/>
      </pc:docMkLst>
      <pc:sldChg chg="addSp delSp modSp">
        <pc:chgData name="Mizrachi, Mark" userId="S::mmizrachi@northwell.edu::b626672d-f584-4993-b46b-d169b20273b9" providerId="AD" clId="Web-{91F9B2B1-14D0-0D70-99A2-CA1AD7B22056}" dt="2024-03-17T01:16:19.939" v="8" actId="1076"/>
        <pc:sldMkLst>
          <pc:docMk/>
          <pc:sldMk cId="1389900947" sldId="256"/>
        </pc:sldMkLst>
        <pc:picChg chg="add mod">
          <ac:chgData name="Mizrachi, Mark" userId="S::mmizrachi@northwell.edu::b626672d-f584-4993-b46b-d169b20273b9" providerId="AD" clId="Web-{91F9B2B1-14D0-0D70-99A2-CA1AD7B22056}" dt="2024-03-17T01:16:05.627" v="2" actId="1076"/>
          <ac:picMkLst>
            <pc:docMk/>
            <pc:sldMk cId="1389900947" sldId="256"/>
            <ac:picMk id="2" creationId="{66855D3F-8ECD-FF46-3616-70BF576F223B}"/>
          </ac:picMkLst>
        </pc:picChg>
        <pc:picChg chg="del">
          <ac:chgData name="Mizrachi, Mark" userId="S::mmizrachi@northwell.edu::b626672d-f584-4993-b46b-d169b20273b9" providerId="AD" clId="Web-{91F9B2B1-14D0-0D70-99A2-CA1AD7B22056}" dt="2024-03-17T01:16:02.721" v="0"/>
          <ac:picMkLst>
            <pc:docMk/>
            <pc:sldMk cId="1389900947" sldId="256"/>
            <ac:picMk id="3" creationId="{877589F8-9895-4D4E-B84E-458344479FDB}"/>
          </ac:picMkLst>
        </pc:picChg>
        <pc:picChg chg="add mod">
          <ac:chgData name="Mizrachi, Mark" userId="S::mmizrachi@northwell.edu::b626672d-f584-4993-b46b-d169b20273b9" providerId="AD" clId="Web-{91F9B2B1-14D0-0D70-99A2-CA1AD7B22056}" dt="2024-03-17T01:16:13.267" v="5" actId="1076"/>
          <ac:picMkLst>
            <pc:docMk/>
            <pc:sldMk cId="1389900947" sldId="256"/>
            <ac:picMk id="4" creationId="{57A8FC7F-A086-120F-C5E7-23C67BCB590B}"/>
          </ac:picMkLst>
        </pc:picChg>
        <pc:picChg chg="del">
          <ac:chgData name="Mizrachi, Mark" userId="S::mmizrachi@northwell.edu::b626672d-f584-4993-b46b-d169b20273b9" providerId="AD" clId="Web-{91F9B2B1-14D0-0D70-99A2-CA1AD7B22056}" dt="2024-03-17T01:16:10.517" v="3"/>
          <ac:picMkLst>
            <pc:docMk/>
            <pc:sldMk cId="1389900947" sldId="256"/>
            <ac:picMk id="5" creationId="{9E89AA4C-134E-3508-967C-A9B71DE3673A}"/>
          </ac:picMkLst>
        </pc:picChg>
        <pc:picChg chg="del">
          <ac:chgData name="Mizrachi, Mark" userId="S::mmizrachi@northwell.edu::b626672d-f584-4993-b46b-d169b20273b9" providerId="AD" clId="Web-{91F9B2B1-14D0-0D70-99A2-CA1AD7B22056}" dt="2024-03-17T01:16:17.236" v="6"/>
          <ac:picMkLst>
            <pc:docMk/>
            <pc:sldMk cId="1389900947" sldId="256"/>
            <ac:picMk id="8" creationId="{166B1CE0-FCD4-0CB9-AE95-D2DE14F3423D}"/>
          </ac:picMkLst>
        </pc:picChg>
        <pc:picChg chg="add mod">
          <ac:chgData name="Mizrachi, Mark" userId="S::mmizrachi@northwell.edu::b626672d-f584-4993-b46b-d169b20273b9" providerId="AD" clId="Web-{91F9B2B1-14D0-0D70-99A2-CA1AD7B22056}" dt="2024-03-17T01:16:19.939" v="8" actId="1076"/>
          <ac:picMkLst>
            <pc:docMk/>
            <pc:sldMk cId="1389900947" sldId="256"/>
            <ac:picMk id="10" creationId="{EAE85862-5706-6E2D-B709-1F6F878D2C8B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CBD60D-5C7E-3F45-A3E3-B17CA91D3C7C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615D28-4735-4546-A805-6F164FEC2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709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619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184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836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306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849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62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701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260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110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715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40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B8649-F1F2-AA44-93D1-2AAB60367080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6868B-6C2C-F945-A925-E9121786F8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074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54E276CA-8BE7-12AB-387A-255CD7677BEE}"/>
              </a:ext>
            </a:extLst>
          </p:cNvPr>
          <p:cNvSpPr txBox="1"/>
          <p:nvPr/>
        </p:nvSpPr>
        <p:spPr>
          <a:xfrm>
            <a:off x="2586577" y="2575022"/>
            <a:ext cx="1951036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11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85F8355E-A37B-4D4C-B58B-99F9F3B61A12}"/>
              </a:ext>
            </a:extLst>
          </p:cNvPr>
          <p:cNvSpPr txBox="1"/>
          <p:nvPr/>
        </p:nvSpPr>
        <p:spPr>
          <a:xfrm rot="16200000">
            <a:off x="1625983" y="1406092"/>
            <a:ext cx="1500673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TMEM-11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CA82E41D-23FE-0EFA-7FE8-5BC194938FFA}"/>
              </a:ext>
            </a:extLst>
          </p:cNvPr>
          <p:cNvSpPr txBox="1"/>
          <p:nvPr/>
        </p:nvSpPr>
        <p:spPr>
          <a:xfrm>
            <a:off x="658435" y="5510492"/>
            <a:ext cx="7912100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/>
              <a:t>Figure S1 Flow cytometry of microglia-specific cell surface markers.</a:t>
            </a:r>
            <a:r>
              <a:rPr lang="en-US" sz="1200" dirty="0"/>
              <a:t> A,B) Microglia isolated using protocol 1; C,D) Microglia isolated using Protocol 3; E,F) Cell suspension from whole brain. 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5FE84B15-ADDC-7F0B-305B-AD77F1094902}"/>
              </a:ext>
            </a:extLst>
          </p:cNvPr>
          <p:cNvSpPr txBox="1"/>
          <p:nvPr/>
        </p:nvSpPr>
        <p:spPr>
          <a:xfrm>
            <a:off x="589973" y="2583292"/>
            <a:ext cx="1432792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4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C975BF65-AE67-136E-3B01-2F7086B8A70C}"/>
              </a:ext>
            </a:extLst>
          </p:cNvPr>
          <p:cNvSpPr txBox="1"/>
          <p:nvPr/>
        </p:nvSpPr>
        <p:spPr>
          <a:xfrm rot="16200000">
            <a:off x="-511850" y="1614081"/>
            <a:ext cx="1323433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11b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="" xmlns:a16="http://schemas.microsoft.com/office/drawing/2014/main" id="{A85F98D8-50EA-34C0-F4EC-33513233D1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137" b="26811"/>
          <a:stretch/>
        </p:blipFill>
        <p:spPr>
          <a:xfrm>
            <a:off x="265920" y="791037"/>
            <a:ext cx="1866649" cy="187761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="" xmlns:a16="http://schemas.microsoft.com/office/drawing/2014/main" id="{90B21DA8-B514-50AA-89BF-84BC905609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85" b="26810"/>
          <a:stretch/>
        </p:blipFill>
        <p:spPr>
          <a:xfrm>
            <a:off x="2355188" y="794813"/>
            <a:ext cx="1951036" cy="187761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4EB1F121-D11D-5E23-EDD7-0C7B336D3D79}"/>
              </a:ext>
            </a:extLst>
          </p:cNvPr>
          <p:cNvSpPr txBox="1"/>
          <p:nvPr/>
        </p:nvSpPr>
        <p:spPr>
          <a:xfrm>
            <a:off x="0" y="73789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8DACED18-42D6-B08E-6585-2DCC8E2E137D}"/>
              </a:ext>
            </a:extLst>
          </p:cNvPr>
          <p:cNvSpPr txBox="1"/>
          <p:nvPr/>
        </p:nvSpPr>
        <p:spPr>
          <a:xfrm>
            <a:off x="2314471" y="67874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353098F0-F293-544B-1587-F72DF65B798A}"/>
              </a:ext>
            </a:extLst>
          </p:cNvPr>
          <p:cNvSpPr txBox="1"/>
          <p:nvPr/>
        </p:nvSpPr>
        <p:spPr>
          <a:xfrm>
            <a:off x="5233798" y="2610412"/>
            <a:ext cx="1313761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4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DE88355D-2E4F-B3D1-9CF1-303925E4E90D}"/>
              </a:ext>
            </a:extLst>
          </p:cNvPr>
          <p:cNvSpPr txBox="1"/>
          <p:nvPr/>
        </p:nvSpPr>
        <p:spPr>
          <a:xfrm>
            <a:off x="7414572" y="2637816"/>
            <a:ext cx="1313761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11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A120898A-4195-F369-E3BC-2880126228D5}"/>
              </a:ext>
            </a:extLst>
          </p:cNvPr>
          <p:cNvSpPr txBox="1"/>
          <p:nvPr/>
        </p:nvSpPr>
        <p:spPr>
          <a:xfrm rot="16200000">
            <a:off x="3975037" y="1528879"/>
            <a:ext cx="1555896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11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0F723DDB-651D-A33F-C2F3-62DFD529B26D}"/>
              </a:ext>
            </a:extLst>
          </p:cNvPr>
          <p:cNvSpPr txBox="1"/>
          <p:nvPr/>
        </p:nvSpPr>
        <p:spPr>
          <a:xfrm rot="16200000">
            <a:off x="6229961" y="1585311"/>
            <a:ext cx="1555896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TMEM-119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="" xmlns:a16="http://schemas.microsoft.com/office/drawing/2014/main" id="{A4D53FCA-F0A2-968E-B4E7-258FB867A7B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2843" r="19652" b="25517"/>
          <a:stretch/>
        </p:blipFill>
        <p:spPr>
          <a:xfrm>
            <a:off x="4789630" y="794814"/>
            <a:ext cx="1962411" cy="195409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="" xmlns:a16="http://schemas.microsoft.com/office/drawing/2014/main" id="{E4BCE516-6C3C-A757-068B-79D31E26578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2597" r="-1" b="25517"/>
          <a:stretch/>
        </p:blipFill>
        <p:spPr>
          <a:xfrm>
            <a:off x="6978948" y="794813"/>
            <a:ext cx="1951036" cy="1954099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DF461A8D-96AB-9DF7-AA3E-1DCE18C1D49D}"/>
              </a:ext>
            </a:extLst>
          </p:cNvPr>
          <p:cNvSpPr txBox="1"/>
          <p:nvPr/>
        </p:nvSpPr>
        <p:spPr>
          <a:xfrm>
            <a:off x="4721540" y="6858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1ECABE86-7BD6-A026-CF1B-9D4DB91616C9}"/>
              </a:ext>
            </a:extLst>
          </p:cNvPr>
          <p:cNvSpPr txBox="1"/>
          <p:nvPr/>
        </p:nvSpPr>
        <p:spPr>
          <a:xfrm>
            <a:off x="6949925" y="724974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="" xmlns:a16="http://schemas.microsoft.com/office/drawing/2014/main" id="{8C653D21-C607-5B4B-50C8-567A30A7C5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137" b="26810"/>
          <a:stretch/>
        </p:blipFill>
        <p:spPr>
          <a:xfrm>
            <a:off x="2469321" y="3355878"/>
            <a:ext cx="1866650" cy="187761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="" xmlns:a16="http://schemas.microsoft.com/office/drawing/2014/main" id="{9DFD9E32-FC9E-362C-FBD3-76141E1AA3C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137" b="26810"/>
          <a:stretch/>
        </p:blipFill>
        <p:spPr>
          <a:xfrm>
            <a:off x="265919" y="3355879"/>
            <a:ext cx="1866650" cy="1877615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BB920808-ACCB-BEDC-3F1C-29BF8DE0BD98}"/>
              </a:ext>
            </a:extLst>
          </p:cNvPr>
          <p:cNvSpPr txBox="1"/>
          <p:nvPr/>
        </p:nvSpPr>
        <p:spPr>
          <a:xfrm>
            <a:off x="11366" y="316424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DAA5F9C9-0F45-59C2-A1AC-379D3A5CD9C0}"/>
              </a:ext>
            </a:extLst>
          </p:cNvPr>
          <p:cNvSpPr txBox="1"/>
          <p:nvPr/>
        </p:nvSpPr>
        <p:spPr>
          <a:xfrm>
            <a:off x="2375131" y="317628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61F0AC61-1D41-E1E4-B8B6-904FC95CD387}"/>
              </a:ext>
            </a:extLst>
          </p:cNvPr>
          <p:cNvSpPr txBox="1"/>
          <p:nvPr/>
        </p:nvSpPr>
        <p:spPr>
          <a:xfrm rot="16200000">
            <a:off x="-491974" y="4156185"/>
            <a:ext cx="1323433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11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E207C3F8-3DC5-C237-1A85-3EEA0EF30EAC}"/>
              </a:ext>
            </a:extLst>
          </p:cNvPr>
          <p:cNvSpPr txBox="1"/>
          <p:nvPr/>
        </p:nvSpPr>
        <p:spPr>
          <a:xfrm>
            <a:off x="580475" y="5233493"/>
            <a:ext cx="1432792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4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B1FA495D-73E4-EE7C-67F6-B71E815C1330}"/>
              </a:ext>
            </a:extLst>
          </p:cNvPr>
          <p:cNvSpPr txBox="1"/>
          <p:nvPr/>
        </p:nvSpPr>
        <p:spPr>
          <a:xfrm>
            <a:off x="2514819" y="5233493"/>
            <a:ext cx="1951036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CD11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6B42C276-4CD7-F3C1-A59C-38194390A89E}"/>
              </a:ext>
            </a:extLst>
          </p:cNvPr>
          <p:cNvSpPr txBox="1"/>
          <p:nvPr/>
        </p:nvSpPr>
        <p:spPr>
          <a:xfrm rot="16200000">
            <a:off x="1630212" y="4142679"/>
            <a:ext cx="1500673" cy="276999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/>
              <a:t>TMEM-119</a:t>
            </a:r>
          </a:p>
        </p:txBody>
      </p:sp>
    </p:spTree>
    <p:extLst>
      <p:ext uri="{BB962C8B-B14F-4D97-AF65-F5344CB8AC3E}">
        <p14:creationId xmlns:p14="http://schemas.microsoft.com/office/powerpoint/2010/main" val="2189732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3B26505F-D2C9-C8D6-098D-D024885D59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0654" y="1119141"/>
            <a:ext cx="4702692" cy="391248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1057C559-2278-925E-26CE-96211939FAE3}"/>
              </a:ext>
            </a:extLst>
          </p:cNvPr>
          <p:cNvSpPr txBox="1"/>
          <p:nvPr/>
        </p:nvSpPr>
        <p:spPr>
          <a:xfrm>
            <a:off x="2102644" y="5031628"/>
            <a:ext cx="4938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Söhne"/>
              </a:rPr>
              <a:t>Figure S2. 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Scatter dot plots of normalized </a:t>
            </a:r>
            <a:r>
              <a:rPr lang="en-US" sz="900" b="1" dirty="0">
                <a:solidFill>
                  <a:srgbClr val="0D0D0D"/>
                </a:solidFill>
                <a:highlight>
                  <a:srgbClr val="FFFFFF"/>
                </a:highlight>
                <a:latin typeface="Söhne"/>
              </a:rPr>
              <a:t>g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ene </a:t>
            </a:r>
            <a:r>
              <a:rPr lang="en-US" sz="900" b="1" dirty="0">
                <a:solidFill>
                  <a:srgbClr val="0D0D0D"/>
                </a:solidFill>
                <a:highlight>
                  <a:srgbClr val="FFFFFF"/>
                </a:highlight>
                <a:latin typeface="Söhne"/>
              </a:rPr>
              <a:t>c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ounts for NMF </a:t>
            </a:r>
            <a:r>
              <a:rPr lang="en-US" sz="900" b="1" i="0" dirty="0" err="1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metagenes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 </a:t>
            </a:r>
            <a:r>
              <a:rPr lang="en-US" sz="900" b="1" dirty="0">
                <a:solidFill>
                  <a:srgbClr val="0D0D0D"/>
                </a:solidFill>
                <a:highlight>
                  <a:srgbClr val="FFFFFF"/>
                </a:highlight>
                <a:latin typeface="Söhne"/>
              </a:rPr>
              <a:t>a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cross </a:t>
            </a:r>
            <a:r>
              <a:rPr lang="en-US" sz="900" b="1" dirty="0">
                <a:solidFill>
                  <a:srgbClr val="0D0D0D"/>
                </a:solidFill>
                <a:highlight>
                  <a:srgbClr val="FFFFFF"/>
                </a:highlight>
                <a:latin typeface="Söhne"/>
              </a:rPr>
              <a:t>a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ll 5 </a:t>
            </a:r>
            <a:r>
              <a:rPr lang="en-US" sz="900" b="1" dirty="0">
                <a:solidFill>
                  <a:srgbClr val="0D0D0D"/>
                </a:solidFill>
                <a:highlight>
                  <a:srgbClr val="FFFFFF"/>
                </a:highlight>
                <a:latin typeface="Söhne"/>
              </a:rPr>
              <a:t>c</a:t>
            </a:r>
            <a:r>
              <a:rPr lang="en-US" sz="900" b="1" i="0" dirty="0">
                <a:solidFill>
                  <a:srgbClr val="0D0D0D"/>
                </a:solidFill>
                <a:effectLst/>
                <a:highlight>
                  <a:srgbClr val="FFFFFF"/>
                </a:highlight>
                <a:latin typeface="Söhne"/>
              </a:rPr>
              <a:t>onditions.</a:t>
            </a:r>
            <a:endParaRPr lang="en-US" sz="900" b="1" dirty="0"/>
          </a:p>
        </p:txBody>
      </p:sp>
    </p:spTree>
    <p:extLst>
      <p:ext uri="{BB962C8B-B14F-4D97-AF65-F5344CB8AC3E}">
        <p14:creationId xmlns:p14="http://schemas.microsoft.com/office/powerpoint/2010/main" val="2264166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0</TotalTime>
  <Words>70</Words>
  <Application>Microsoft Office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öhn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Mizrachi</dc:creator>
  <cp:lastModifiedBy>Rajalakshmi Thangaraj</cp:lastModifiedBy>
  <cp:revision>3</cp:revision>
  <cp:lastPrinted>2023-09-11T18:03:42Z</cp:lastPrinted>
  <dcterms:created xsi:type="dcterms:W3CDTF">2023-07-21T15:41:11Z</dcterms:created>
  <dcterms:modified xsi:type="dcterms:W3CDTF">2024-03-28T03:01:11Z</dcterms:modified>
</cp:coreProperties>
</file>